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302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4922">
          <p15:clr>
            <a:srgbClr val="A4A3A4"/>
          </p15:clr>
        </p15:guide>
        <p15:guide id="4" pos="39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ulie Aspden" initials="" lastIdx="1" clrIdx="0"/>
  <p:cmAuthor id="1" name="Julie Aspden" initials="JA" lastIdx="18" clrIdx="1">
    <p:extLst>
      <p:ext uri="{19B8F6BF-5375-455C-9EA6-DF929625EA0E}">
        <p15:presenceInfo xmlns:p15="http://schemas.microsoft.com/office/powerpoint/2012/main" userId="S::fbsjas@leeds.ac.uk::647d6aff-221e-4d07-9989-160857ddfb47" providerId="AD"/>
      </p:ext>
    </p:extLst>
  </p:cmAuthor>
  <p:cmAuthor id="2" name="Juan Fontana Jordan De Urries" initials="JFJDU" lastIdx="10" clrIdx="2">
    <p:extLst>
      <p:ext uri="{19B8F6BF-5375-455C-9EA6-DF929625EA0E}">
        <p15:presenceInfo xmlns:p15="http://schemas.microsoft.com/office/powerpoint/2012/main" userId="S::fbsjfo@leeds.ac.uk::3462a2bb-b037-4c0e-aa18-b1f8427319b3" providerId="AD"/>
      </p:ext>
    </p:extLst>
  </p:cmAuthor>
  <p:cmAuthor id="3" name="Karl Norris" initials="KN" lastIdx="6" clrIdx="3">
    <p:extLst>
      <p:ext uri="{19B8F6BF-5375-455C-9EA6-DF929625EA0E}">
        <p15:presenceInfo xmlns:p15="http://schemas.microsoft.com/office/powerpoint/2012/main" userId="Karl Norris" providerId="None"/>
      </p:ext>
    </p:extLst>
  </p:cmAuthor>
  <p:cmAuthor id="4" name="Tayah Hopes" initials="TH" lastIdx="2" clrIdx="4">
    <p:extLst>
      <p:ext uri="{19B8F6BF-5375-455C-9EA6-DF929625EA0E}">
        <p15:presenceInfo xmlns:p15="http://schemas.microsoft.com/office/powerpoint/2012/main" userId="S::fbstsho@leeds.ac.uk::4d3ff96e-e068-4a11-9e61-a469e3977832" providerId="AD"/>
      </p:ext>
    </p:extLst>
  </p:cmAuthor>
  <p:cmAuthor id="5" name="Karl Norris" initials="KN [2]" lastIdx="1" clrIdx="5">
    <p:extLst>
      <p:ext uri="{19B8F6BF-5375-455C-9EA6-DF929625EA0E}">
        <p15:presenceInfo xmlns:p15="http://schemas.microsoft.com/office/powerpoint/2012/main" userId="S::fbskn@leeds.ac.uk::8ae02d21-a200-4823-b6f3-444a95ac573a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9193"/>
    <a:srgbClr val="F67A26"/>
    <a:srgbClr val="FEC623"/>
    <a:srgbClr val="4273CA"/>
    <a:srgbClr val="16B050"/>
    <a:srgbClr val="2E5290"/>
    <a:srgbClr val="00FDFF"/>
    <a:srgbClr val="00FA00"/>
    <a:srgbClr val="73FB79"/>
    <a:srgbClr val="FF2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0E3FDE45-AF77-4B5C-9715-49D594BDF05E}" styleName="Light Style 1 - Accent 2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BC89EF96-8CEA-46FF-86C4-4CE0E7609802}" styleName="Light Style 3 - Accent 1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ED083AE6-46FA-4A59-8FB0-9F97EB10719F}" styleName="Light Style 3 - Accent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BDBED569-4797-4DF1-A0F4-6AAB3CD982D8}" styleName="Light Style 3 - Accent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Dark Style 2 - Accent 5/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Dark Style 2 - Accent 3/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Dark Style 2 - Accent 1/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AF606853-7671-496A-8E4F-DF71F8EC918B}" styleName="Dark Style 1 - Accent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202B0CA-FC54-4496-8BCA-5EF66A818D29}" styleName="Dark Style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25E5076-3810-47DD-B79F-674D7AD40C01}" styleName="Dark Style 1 - Accent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Dark Style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3584" y="184"/>
      </p:cViewPr>
      <p:guideLst>
        <p:guide orient="horz" pos="3120"/>
        <p:guide pos="2160"/>
        <p:guide orient="horz" pos="4922"/>
        <p:guide pos="39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D80DBE6-65EC-412A-92B9-0C94CCC51376}" type="datetimeFigureOut">
              <a:rPr lang="en-US"/>
              <a:t>6/2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975935-0359-4C45-8C27-115463D3B7CD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1431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05443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6284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201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562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776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629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929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9866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389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3724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0097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299A19-9056-D447-BB4E-DDBAAB2AAE17}" type="datetimeFigureOut">
              <a:rPr lang="en-US" smtClean="0"/>
              <a:t>6/22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CF8DD-9D6D-904F-902C-7584E2AA3CC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19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15CD162A-1EC5-B643-8176-43538DB3AAD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4269578"/>
              </p:ext>
            </p:extLst>
          </p:nvPr>
        </p:nvGraphicFramePr>
        <p:xfrm>
          <a:off x="614181" y="559275"/>
          <a:ext cx="5359078" cy="8547652"/>
        </p:xfrm>
        <a:graphic>
          <a:graphicData uri="http://schemas.openxmlformats.org/drawingml/2006/table">
            <a:tbl>
              <a:tblPr firstRow="1" firstCol="1" bandRow="1">
                <a:tableStyleId>{8799B23B-EC83-4686-B30A-512413B5E67A}</a:tableStyleId>
              </a:tblPr>
              <a:tblGrid>
                <a:gridCol w="1944307">
                  <a:extLst>
                    <a:ext uri="{9D8B030D-6E8A-4147-A177-3AD203B41FA5}">
                      <a16:colId xmlns:a16="http://schemas.microsoft.com/office/drawing/2014/main" val="2919024598"/>
                    </a:ext>
                  </a:extLst>
                </a:gridCol>
                <a:gridCol w="1132925">
                  <a:extLst>
                    <a:ext uri="{9D8B030D-6E8A-4147-A177-3AD203B41FA5}">
                      <a16:colId xmlns:a16="http://schemas.microsoft.com/office/drawing/2014/main" val="1503127714"/>
                    </a:ext>
                  </a:extLst>
                </a:gridCol>
                <a:gridCol w="1264794">
                  <a:extLst>
                    <a:ext uri="{9D8B030D-6E8A-4147-A177-3AD203B41FA5}">
                      <a16:colId xmlns:a16="http://schemas.microsoft.com/office/drawing/2014/main" val="3818705066"/>
                    </a:ext>
                  </a:extLst>
                </a:gridCol>
                <a:gridCol w="1017052">
                  <a:extLst>
                    <a:ext uri="{9D8B030D-6E8A-4147-A177-3AD203B41FA5}">
                      <a16:colId xmlns:a16="http://schemas.microsoft.com/office/drawing/2014/main" val="1775029841"/>
                    </a:ext>
                  </a:extLst>
                </a:gridCol>
              </a:tblGrid>
              <a:tr h="305129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 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Testis 80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Ovary 80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Testis Polysom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786990994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Data collectio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681374294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Microscop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EI Titan KRIO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EI Titan KRIO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EI Titan KRIO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312655750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Voltage (keV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30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30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30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068576637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Detector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EI Falcon III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EI Falcon III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FEI Falcon III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714405329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Magnificatio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x75,00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x75,00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x75,00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89404496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Defocus rang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-2 to -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-2 to -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-2 to -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134848614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Pixel size (Å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.06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.06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.06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493969609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Electron dose (e</a:t>
                      </a:r>
                      <a:r>
                        <a:rPr lang="en-GB" sz="1000" baseline="30000">
                          <a:effectLst/>
                        </a:rPr>
                        <a:t>-</a:t>
                      </a:r>
                      <a:r>
                        <a:rPr lang="en-GB" sz="1000">
                          <a:effectLst/>
                        </a:rPr>
                        <a:t>/Å</a:t>
                      </a:r>
                      <a:r>
                        <a:rPr lang="en-GB" sz="1000" baseline="30000">
                          <a:effectLst/>
                        </a:rPr>
                        <a:t>2</a:t>
                      </a:r>
                      <a:r>
                        <a:rPr lang="en-GB" sz="1000">
                          <a:effectLst/>
                        </a:rPr>
                        <a:t>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8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990543775"/>
                  </a:ext>
                </a:extLst>
              </a:tr>
              <a:tr h="305129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Electron dose per frame (e</a:t>
                      </a:r>
                      <a:r>
                        <a:rPr lang="en-GB" sz="1000" baseline="30000">
                          <a:effectLst/>
                        </a:rPr>
                        <a:t>-</a:t>
                      </a:r>
                      <a:r>
                        <a:rPr lang="en-GB" sz="1000">
                          <a:effectLst/>
                        </a:rPr>
                        <a:t>/Å</a:t>
                      </a:r>
                      <a:r>
                        <a:rPr lang="en-GB" sz="1000" baseline="30000">
                          <a:effectLst/>
                        </a:rPr>
                        <a:t>2</a:t>
                      </a:r>
                      <a:r>
                        <a:rPr lang="en-GB" sz="1000">
                          <a:effectLst/>
                        </a:rPr>
                        <a:t>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.3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.3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.3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888351646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Exposure (sec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4292130501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No. of fram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6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6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6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277260393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No. of micrograph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5,24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9,076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2,75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99491239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Data processing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173398586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Symmetry Point Group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C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C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C1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006820160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Final particle number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46,87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85,91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10,392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880841517"/>
                  </a:ext>
                </a:extLst>
              </a:tr>
              <a:tr h="305129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Map average resolution 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(</a:t>
                      </a:r>
                      <a:r>
                        <a:rPr lang="en-GB" sz="1000" err="1">
                          <a:effectLst/>
                        </a:rPr>
                        <a:t>Å</a:t>
                      </a:r>
                      <a:r>
                        <a:rPr lang="en-GB" sz="1000">
                          <a:effectLst/>
                        </a:rPr>
                        <a:t>, 0.143 FSC threshold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3.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3.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4.9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914691518"/>
                  </a:ext>
                </a:extLst>
              </a:tr>
              <a:tr h="20972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Map sharpening B-factor (Å</a:t>
                      </a:r>
                      <a:r>
                        <a:rPr lang="en-GB" sz="1000" baseline="30000">
                          <a:effectLst/>
                        </a:rPr>
                        <a:t>2</a:t>
                      </a:r>
                      <a:r>
                        <a:rPr lang="en-GB" sz="1000">
                          <a:effectLst/>
                        </a:rPr>
                        <a:t>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-150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-11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-19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25635489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Multi-body refinement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N/A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N/A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992443422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Large subunit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081477669"/>
                  </a:ext>
                </a:extLst>
              </a:tr>
              <a:tr h="31458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  Map average resolution 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  (</a:t>
                      </a:r>
                      <a:r>
                        <a:rPr lang="en-GB" sz="1000" err="1">
                          <a:effectLst/>
                        </a:rPr>
                        <a:t>Å</a:t>
                      </a:r>
                      <a:r>
                        <a:rPr lang="en-GB" sz="1000">
                          <a:effectLst/>
                        </a:rPr>
                        <a:t>, 0.143 FSC threshold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3.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537676645"/>
                  </a:ext>
                </a:extLst>
              </a:tr>
              <a:tr h="305129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  Map sharpening B-factor (Å</a:t>
                      </a:r>
                      <a:r>
                        <a:rPr lang="en-GB" sz="1000" baseline="30000">
                          <a:effectLst/>
                        </a:rPr>
                        <a:t>2</a:t>
                      </a:r>
                      <a:r>
                        <a:rPr lang="en-GB" sz="1000">
                          <a:effectLst/>
                        </a:rPr>
                        <a:t>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-143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037408286"/>
                  </a:ext>
                </a:extLst>
              </a:tr>
              <a:tr h="20972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Small subunit without head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954300624"/>
                  </a:ext>
                </a:extLst>
              </a:tr>
              <a:tr h="31458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  Map average resolution 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  (</a:t>
                      </a:r>
                      <a:r>
                        <a:rPr lang="en-GB" sz="1000" err="1">
                          <a:effectLst/>
                        </a:rPr>
                        <a:t>Å</a:t>
                      </a:r>
                      <a:r>
                        <a:rPr lang="en-GB" sz="1000">
                          <a:effectLst/>
                        </a:rPr>
                        <a:t>, 0.143 FSC threshold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3.7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890150182"/>
                  </a:ext>
                </a:extLst>
              </a:tr>
              <a:tr h="305129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  Map sharpening B-factor (Å</a:t>
                      </a:r>
                      <a:r>
                        <a:rPr lang="en-GB" sz="1000" baseline="30000">
                          <a:effectLst/>
                        </a:rPr>
                        <a:t>2</a:t>
                      </a:r>
                      <a:r>
                        <a:rPr lang="en-GB" sz="1000">
                          <a:effectLst/>
                        </a:rPr>
                        <a:t>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-165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431550822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Head of small subunit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026447668"/>
                  </a:ext>
                </a:extLst>
              </a:tr>
              <a:tr h="31458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  Map average resolution 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  (</a:t>
                      </a:r>
                      <a:r>
                        <a:rPr lang="en-GB" sz="1000" err="1">
                          <a:effectLst/>
                        </a:rPr>
                        <a:t>Å</a:t>
                      </a:r>
                      <a:r>
                        <a:rPr lang="en-GB" sz="1000">
                          <a:effectLst/>
                        </a:rPr>
                        <a:t>, 0.143 FSC threshold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4.8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451252800"/>
                  </a:ext>
                </a:extLst>
              </a:tr>
              <a:tr h="16318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  Map sharpening B-factor (Å</a:t>
                      </a:r>
                      <a:r>
                        <a:rPr lang="en-GB" sz="1000" baseline="30000">
                          <a:effectLst/>
                        </a:rPr>
                        <a:t>2</a:t>
                      </a:r>
                      <a:r>
                        <a:rPr lang="en-GB" sz="1000">
                          <a:effectLst/>
                        </a:rPr>
                        <a:t>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-224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314411494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Refinement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795652379"/>
                  </a:ext>
                </a:extLst>
              </a:tr>
              <a:tr h="194455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Initial model (PDB code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4v6w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Testis 80S model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Testis 80S model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72920616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Model Compositio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4232003583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Non-hydrogen atom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19,765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16,955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19,005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297431217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Amino acid residu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2,097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1,750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1,764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652788139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Nucleotide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,916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,912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,003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457138463"/>
                  </a:ext>
                </a:extLst>
              </a:tr>
              <a:tr h="20972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R.M.S.D. from ideal geometry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396387659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Bond lengths (</a:t>
                      </a:r>
                      <a:r>
                        <a:rPr lang="en-GB" sz="1000" err="1">
                          <a:effectLst/>
                        </a:rPr>
                        <a:t>Å</a:t>
                      </a:r>
                      <a:r>
                        <a:rPr lang="en-GB" sz="1000">
                          <a:effectLst/>
                        </a:rPr>
                        <a:t>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20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14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13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990209255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Bond angles (º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766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484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455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419729251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Validation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301164157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</a:t>
                      </a:r>
                      <a:r>
                        <a:rPr lang="en-GB" sz="1000" err="1">
                          <a:effectLst/>
                        </a:rPr>
                        <a:t>Clashscore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2.54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.16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5.01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433306986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</a:t>
                      </a:r>
                      <a:r>
                        <a:rPr lang="en-GB" sz="1000" err="1">
                          <a:effectLst/>
                        </a:rPr>
                        <a:t>Rotamer</a:t>
                      </a:r>
                      <a:r>
                        <a:rPr lang="en-GB" sz="1000">
                          <a:effectLst/>
                        </a:rPr>
                        <a:t> outliers (%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2.47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82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43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2605335404"/>
                  </a:ext>
                </a:extLst>
              </a:tr>
              <a:tr h="20972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Ramachandran plot statistics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059378563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Favored (%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3.37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2.68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2.92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183602429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Allowed (%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5.82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6.32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6.61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227024355"/>
                  </a:ext>
                </a:extLst>
              </a:tr>
              <a:tr h="152564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    Outliers (%)</a:t>
                      </a:r>
                      <a:endParaRPr lang="en-GB" sz="10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81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.01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47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378114367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SC model – map </a:t>
                      </a: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(</a:t>
                      </a:r>
                      <a:r>
                        <a:rPr lang="en-GB" sz="1000" b="1" kern="120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Å</a:t>
                      </a:r>
                      <a:r>
                        <a:rPr lang="en-GB" sz="1000" b="1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 0.5 threshold)</a:t>
                      </a:r>
                    </a:p>
                  </a:txBody>
                  <a:tcPr marL="52374" marR="52374" marT="0" marB="0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.4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3.1</a:t>
                      </a:r>
                    </a:p>
                  </a:txBody>
                  <a:tcPr marL="52374" marR="52374" marT="0" marB="0" anchor="ctr"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000" kern="120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4.6</a:t>
                      </a:r>
                    </a:p>
                  </a:txBody>
                  <a:tcPr marL="52374" marR="52374" marT="0" marB="0" anchor="ctr"/>
                </a:tc>
                <a:extLst>
                  <a:ext uri="{0D108BD9-81ED-4DB2-BD59-A6C34878D82A}">
                    <a16:rowId xmlns:a16="http://schemas.microsoft.com/office/drawing/2014/main" val="123802276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161D4CA1-08CC-FB4D-B456-0A4B4A984D0B}"/>
              </a:ext>
            </a:extLst>
          </p:cNvPr>
          <p:cNvSpPr txBox="1"/>
          <p:nvPr/>
        </p:nvSpPr>
        <p:spPr>
          <a:xfrm>
            <a:off x="5461618" y="38100"/>
            <a:ext cx="1251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 Tabl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B44613-0EB4-CF4E-B567-A92451035A12}"/>
              </a:ext>
            </a:extLst>
          </p:cNvPr>
          <p:cNvSpPr txBox="1"/>
          <p:nvPr/>
        </p:nvSpPr>
        <p:spPr>
          <a:xfrm>
            <a:off x="453146" y="9258771"/>
            <a:ext cx="6260353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/>
              <a:t>Sup Table 2: Summary of data collection, image processing, model building, refinement and validation statistics</a:t>
            </a:r>
          </a:p>
        </p:txBody>
      </p:sp>
    </p:spTree>
    <p:extLst>
      <p:ext uri="{BB962C8B-B14F-4D97-AF65-F5344CB8AC3E}">
        <p14:creationId xmlns:p14="http://schemas.microsoft.com/office/powerpoint/2010/main" val="2080014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432</Words>
  <Application>Microsoft Macintosh PowerPoint</Application>
  <PresentationFormat>A4 Paper (210x297 mm)</PresentationFormat>
  <Paragraphs>18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e Aspden</dc:creator>
  <cp:lastModifiedBy>Julie Aspden</cp:lastModifiedBy>
  <cp:revision>5</cp:revision>
  <cp:lastPrinted>2021-04-23T12:48:59Z</cp:lastPrinted>
  <dcterms:created xsi:type="dcterms:W3CDTF">2019-05-17T07:50:07Z</dcterms:created>
  <dcterms:modified xsi:type="dcterms:W3CDTF">2021-06-22T07:06:06Z</dcterms:modified>
</cp:coreProperties>
</file>